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51" autoAdjust="0"/>
    <p:restoredTop sz="94660"/>
  </p:normalViewPr>
  <p:slideViewPr>
    <p:cSldViewPr snapToGrid="0">
      <p:cViewPr varScale="1">
        <p:scale>
          <a:sx n="90" d="100"/>
          <a:sy n="90" d="100"/>
        </p:scale>
        <p:origin x="522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7EA0F3-1091-4F77-B5B9-26C93D176D39}" type="datetimeFigureOut">
              <a:rPr lang="en-US" smtClean="0"/>
              <a:t>11/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0156A7-10C7-4A6C-810E-D1C529E671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99532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7EA0F3-1091-4F77-B5B9-26C93D176D39}" type="datetimeFigureOut">
              <a:rPr lang="en-US" smtClean="0"/>
              <a:t>11/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0156A7-10C7-4A6C-810E-D1C529E671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20731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7EA0F3-1091-4F77-B5B9-26C93D176D39}" type="datetimeFigureOut">
              <a:rPr lang="en-US" smtClean="0"/>
              <a:t>11/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0156A7-10C7-4A6C-810E-D1C529E671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14012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7EA0F3-1091-4F77-B5B9-26C93D176D39}" type="datetimeFigureOut">
              <a:rPr lang="en-US" smtClean="0"/>
              <a:t>11/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0156A7-10C7-4A6C-810E-D1C529E671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00293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7EA0F3-1091-4F77-B5B9-26C93D176D39}" type="datetimeFigureOut">
              <a:rPr lang="en-US" smtClean="0"/>
              <a:t>11/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0156A7-10C7-4A6C-810E-D1C529E671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74452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7EA0F3-1091-4F77-B5B9-26C93D176D39}" type="datetimeFigureOut">
              <a:rPr lang="en-US" smtClean="0"/>
              <a:t>11/7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0156A7-10C7-4A6C-810E-D1C529E671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38963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7EA0F3-1091-4F77-B5B9-26C93D176D39}" type="datetimeFigureOut">
              <a:rPr lang="en-US" smtClean="0"/>
              <a:t>11/7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0156A7-10C7-4A6C-810E-D1C529E671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77779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7EA0F3-1091-4F77-B5B9-26C93D176D39}" type="datetimeFigureOut">
              <a:rPr lang="en-US" smtClean="0"/>
              <a:t>11/7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0156A7-10C7-4A6C-810E-D1C529E671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25390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7EA0F3-1091-4F77-B5B9-26C93D176D39}" type="datetimeFigureOut">
              <a:rPr lang="en-US" smtClean="0"/>
              <a:t>11/7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0156A7-10C7-4A6C-810E-D1C529E671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93997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7EA0F3-1091-4F77-B5B9-26C93D176D39}" type="datetimeFigureOut">
              <a:rPr lang="en-US" smtClean="0"/>
              <a:t>11/7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0156A7-10C7-4A6C-810E-D1C529E671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45535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7EA0F3-1091-4F77-B5B9-26C93D176D39}" type="datetimeFigureOut">
              <a:rPr lang="en-US" smtClean="0"/>
              <a:t>11/7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0156A7-10C7-4A6C-810E-D1C529E671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95945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7EA0F3-1091-4F77-B5B9-26C93D176D39}" type="datetimeFigureOut">
              <a:rPr lang="en-US" smtClean="0"/>
              <a:t>11/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0156A7-10C7-4A6C-810E-D1C529E671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52127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1049096" y="828445"/>
            <a:ext cx="4271681" cy="3047122"/>
            <a:chOff x="1580724" y="1136789"/>
            <a:chExt cx="5224721" cy="2673662"/>
          </a:xfrm>
        </p:grpSpPr>
        <p:pic>
          <p:nvPicPr>
            <p:cNvPr id="8" name="Picture 8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580724" y="1258521"/>
              <a:ext cx="5224721" cy="255193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2" name="Group 1"/>
            <p:cNvGrpSpPr/>
            <p:nvPr/>
          </p:nvGrpSpPr>
          <p:grpSpPr>
            <a:xfrm>
              <a:off x="1580725" y="1136789"/>
              <a:ext cx="290605" cy="1823000"/>
              <a:chOff x="1474820" y="1323201"/>
              <a:chExt cx="3524349" cy="1823000"/>
            </a:xfrm>
          </p:grpSpPr>
          <p:sp>
            <p:nvSpPr>
              <p:cNvPr id="5" name="Text Box 4"/>
              <p:cNvSpPr txBox="1">
                <a:spLocks noChangeArrowheads="1"/>
              </p:cNvSpPr>
              <p:nvPr/>
            </p:nvSpPr>
            <p:spPr bwMode="auto">
              <a:xfrm>
                <a:off x="1474820" y="1323201"/>
                <a:ext cx="3524349" cy="36818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rPr>
                  <a:t>A</a:t>
                </a:r>
              </a:p>
            </p:txBody>
          </p:sp>
          <p:sp>
            <p:nvSpPr>
              <p:cNvPr id="6" name="Text Box 5"/>
              <p:cNvSpPr txBox="1">
                <a:spLocks noChangeArrowheads="1"/>
              </p:cNvSpPr>
              <p:nvPr/>
            </p:nvSpPr>
            <p:spPr bwMode="auto">
              <a:xfrm rot="16200000">
                <a:off x="1429329" y="1968312"/>
                <a:ext cx="1223431" cy="11323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ko-KR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Body weight (kg)</a:t>
                </a:r>
                <a:endParaRPr kumimoji="0" lang="en-US" alt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</p:grpSp>
      </p:grpSp>
      <p:sp>
        <p:nvSpPr>
          <p:cNvPr id="7" name="Rectangle 11"/>
          <p:cNvSpPr>
            <a:spLocks noChangeArrowheads="1"/>
          </p:cNvSpPr>
          <p:nvPr/>
        </p:nvSpPr>
        <p:spPr bwMode="auto">
          <a:xfrm>
            <a:off x="1791530" y="4540615"/>
            <a:ext cx="8819763" cy="83099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ts val="1000"/>
              </a:spcAft>
              <a:buClrTx/>
              <a:buSzTx/>
              <a:buFontTx/>
              <a:buNone/>
              <a:tabLst/>
            </a:pPr>
            <a:r>
              <a:rPr kumimoji="0" lang="en-US" altLang="ko-KR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ure S1.</a:t>
            </a:r>
            <a:r>
              <a:rPr kumimoji="0" lang="en-US" altLang="ko-KR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0" lang="en-US" altLang="ko-KR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Body weight change, body</a:t>
            </a:r>
            <a:r>
              <a:rPr kumimoji="0" lang="en-US" altLang="ko-KR" sz="1200" b="1" i="0" u="none" strike="noStrike" cap="none" normalizeH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composition by DXA scan and mineral content in bone.</a:t>
            </a:r>
            <a:r>
              <a:rPr kumimoji="0" lang="en-US" altLang="ko-KR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Body weights were measured at 0, 3, and 6 weeks (n=10/group). Body weight data are expressed as mean body weight in kilogram ± S.E.M. Differences between treatment means were determined by pairwise </a:t>
            </a:r>
            <a:r>
              <a:rPr kumimoji="0" lang="en-US" altLang="ko-KR" sz="1200" b="0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kumimoji="0" lang="en-US" altLang="ko-KR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-tests</a:t>
            </a:r>
            <a:r>
              <a:rPr kumimoji="0" lang="en-US" altLang="ko-KR" sz="1200" b="0" i="0" u="none" strike="noStrike" cap="none" normalizeH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(A</a:t>
            </a:r>
            <a:r>
              <a:rPr kumimoji="0" lang="en-US" altLang="ko-KR" sz="1200" b="0" i="0" u="none" strike="noStrike" cap="none" normalizeH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), p</a:t>
            </a:r>
            <a:r>
              <a:rPr lang="en-US" altLang="ko-KR" sz="120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rcentage </a:t>
            </a:r>
            <a:r>
              <a:rPr lang="en-US" altLang="ko-KR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f fat in carcass (B) and areal bone mean density (BMD) of </a:t>
            </a:r>
            <a:r>
              <a:rPr lang="en-US" altLang="ko-KR" sz="120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ight femur (C</a:t>
            </a:r>
            <a:r>
              <a:rPr lang="en-US" altLang="ko-KR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, by Dual-energy X-ray absorptiometry (</a:t>
            </a:r>
            <a:r>
              <a:rPr lang="en-US" altLang="ko-KR" sz="120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XA).</a:t>
            </a:r>
            <a:endParaRPr kumimoji="0" lang="en-US" altLang="en-US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" name="Picture 9"/>
          <p:cNvPicPr>
            <a:picLocks noChangeAspect="1"/>
          </p:cNvPicPr>
          <p:nvPr/>
        </p:nvPicPr>
        <p:blipFill rotWithShape="1">
          <a:blip r:embed="rId3"/>
          <a:srcRect l="39506" t="17448" r="33372" b="41706"/>
          <a:stretch/>
        </p:blipFill>
        <p:spPr>
          <a:xfrm>
            <a:off x="4633109" y="938313"/>
            <a:ext cx="3072808" cy="3463566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 rotWithShape="1">
          <a:blip r:embed="rId4"/>
          <a:srcRect l="41773" t="16977" r="33372" b="44079"/>
          <a:stretch/>
        </p:blipFill>
        <p:spPr>
          <a:xfrm>
            <a:off x="8022054" y="938313"/>
            <a:ext cx="3030279" cy="3325343"/>
          </a:xfrm>
          <a:prstGeom prst="rect">
            <a:avLst/>
          </a:prstGeom>
        </p:spPr>
      </p:pic>
      <p:sp>
        <p:nvSpPr>
          <p:cNvPr id="12" name="Text Box 4"/>
          <p:cNvSpPr txBox="1">
            <a:spLocks noChangeArrowheads="1"/>
          </p:cNvSpPr>
          <p:nvPr/>
        </p:nvSpPr>
        <p:spPr bwMode="auto">
          <a:xfrm>
            <a:off x="4912270" y="938313"/>
            <a:ext cx="237596" cy="41961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rPr>
              <a:t>B</a:t>
            </a:r>
          </a:p>
        </p:txBody>
      </p:sp>
      <p:sp>
        <p:nvSpPr>
          <p:cNvPr id="13" name="Text Box 4"/>
          <p:cNvSpPr txBox="1">
            <a:spLocks noChangeArrowheads="1"/>
          </p:cNvSpPr>
          <p:nvPr/>
        </p:nvSpPr>
        <p:spPr bwMode="auto">
          <a:xfrm>
            <a:off x="8016994" y="980845"/>
            <a:ext cx="237596" cy="41961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rPr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21551794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40</TotalTime>
  <Words>96</Words>
  <Application>Microsoft Office PowerPoint</Application>
  <PresentationFormat>Widescreen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맑은 고딕</vt:lpstr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olano-Aguilar, Gloria</dc:creator>
  <cp:lastModifiedBy>Solano-Aguilar, Gloria</cp:lastModifiedBy>
  <cp:revision>10</cp:revision>
  <dcterms:created xsi:type="dcterms:W3CDTF">2018-09-19T14:21:11Z</dcterms:created>
  <dcterms:modified xsi:type="dcterms:W3CDTF">2018-11-07T23:17:22Z</dcterms:modified>
</cp:coreProperties>
</file>